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38" saveSubsetFonts="1" autoCompressPictures="0">
  <p:sldMasterIdLst>
    <p:sldMasterId id="2147483684" r:id="rId1"/>
  </p:sldMasterIdLst>
  <p:notesMasterIdLst>
    <p:notesMasterId r:id="rId4"/>
  </p:notesMasterIdLst>
  <p:sldIdLst>
    <p:sldId id="267" r:id="rId2"/>
    <p:sldId id="292" r:id="rId3"/>
  </p:sldIdLst>
  <p:sldSz cx="6300788" cy="82073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ppenberg" initials="C" lastIdx="2" clrIdx="0">
    <p:extLst>
      <p:ext uri="{19B8F6BF-5375-455C-9EA6-DF929625EA0E}">
        <p15:presenceInfo xmlns:p15="http://schemas.microsoft.com/office/powerpoint/2012/main" userId="Cappenber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95332" autoAdjust="0"/>
  </p:normalViewPr>
  <p:slideViewPr>
    <p:cSldViewPr snapToGrid="0">
      <p:cViewPr>
        <p:scale>
          <a:sx n="140" d="100"/>
          <a:sy n="140" d="100"/>
        </p:scale>
        <p:origin x="1594" y="-22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DEA036-15BC-4B48-BE03-AAB437B05833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4725" y="1143000"/>
            <a:ext cx="2368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E7D2CC-C2F8-A64D-93E3-F2E64EE5B16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2984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1pPr>
    <a:lvl2pPr marL="395661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2pPr>
    <a:lvl3pPr marL="791322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3pPr>
    <a:lvl4pPr marL="1186983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4pPr>
    <a:lvl5pPr marL="1582644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5pPr>
    <a:lvl6pPr marL="1978304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6pPr>
    <a:lvl7pPr marL="2373965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7pPr>
    <a:lvl8pPr marL="2769626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8pPr>
    <a:lvl9pPr marL="3165287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4725" y="1143000"/>
            <a:ext cx="23685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E7D2CC-C2F8-A64D-93E3-F2E64EE5B16E}" type="slidenum">
              <a:rPr lang="en-US" smtClean="0"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2701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9080C23-0487-6301-D130-17564D80D5E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10A69A2-A3E3-6847-833B-9E983A6ABA3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44725" y="1143000"/>
            <a:ext cx="236855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6753249E-C73C-622B-5749-90894354F85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D3DB11-DFCA-2EC4-D056-FF19EAFE0BE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E7D2CC-C2F8-A64D-93E3-F2E64EE5B16E}" type="slidenum">
              <a:rPr lang="en-US" smtClean="0"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397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559" y="1343199"/>
            <a:ext cx="5355670" cy="2857382"/>
          </a:xfrm>
        </p:spPr>
        <p:txBody>
          <a:bodyPr anchor="b"/>
          <a:lstStyle>
            <a:lvl1pPr algn="ctr">
              <a:defRPr sz="413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4310772"/>
            <a:ext cx="4725591" cy="1981549"/>
          </a:xfrm>
        </p:spPr>
        <p:txBody>
          <a:bodyPr/>
          <a:lstStyle>
            <a:lvl1pPr marL="0" indent="0" algn="ctr">
              <a:buNone/>
              <a:defRPr sz="1654"/>
            </a:lvl1pPr>
            <a:lvl2pPr marL="315057" indent="0" algn="ctr">
              <a:buNone/>
              <a:defRPr sz="1378"/>
            </a:lvl2pPr>
            <a:lvl3pPr marL="630113" indent="0" algn="ctr">
              <a:buNone/>
              <a:defRPr sz="1240"/>
            </a:lvl3pPr>
            <a:lvl4pPr marL="945170" indent="0" algn="ctr">
              <a:buNone/>
              <a:defRPr sz="1103"/>
            </a:lvl4pPr>
            <a:lvl5pPr marL="1260226" indent="0" algn="ctr">
              <a:buNone/>
              <a:defRPr sz="1103"/>
            </a:lvl5pPr>
            <a:lvl6pPr marL="1575283" indent="0" algn="ctr">
              <a:buNone/>
              <a:defRPr sz="1103"/>
            </a:lvl6pPr>
            <a:lvl7pPr marL="1890339" indent="0" algn="ctr">
              <a:buNone/>
              <a:defRPr sz="1103"/>
            </a:lvl7pPr>
            <a:lvl8pPr marL="2205396" indent="0" algn="ctr">
              <a:buNone/>
              <a:defRPr sz="1103"/>
            </a:lvl8pPr>
            <a:lvl9pPr marL="2520452" indent="0" algn="ctr">
              <a:buNone/>
              <a:defRPr sz="110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33AB-3E51-4445-A1CF-2ADC5E3954CB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906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B227C-308B-6849-8B9D-8396633A9746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188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436967"/>
            <a:ext cx="1358607" cy="6955371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80" y="436967"/>
            <a:ext cx="3997062" cy="6955371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D43AB-BC5C-0E4A-8281-D0B64264A8CE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420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8506-30DD-1840-9335-35199E9BEFE5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738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8" y="2046147"/>
            <a:ext cx="5434430" cy="3414039"/>
          </a:xfrm>
        </p:spPr>
        <p:txBody>
          <a:bodyPr anchor="b"/>
          <a:lstStyle>
            <a:lvl1pPr>
              <a:defRPr sz="413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8" y="5492484"/>
            <a:ext cx="5434430" cy="1795363"/>
          </a:xfrm>
        </p:spPr>
        <p:txBody>
          <a:bodyPr/>
          <a:lstStyle>
            <a:lvl1pPr marL="0" indent="0">
              <a:buNone/>
              <a:defRPr sz="1654">
                <a:solidFill>
                  <a:schemeClr val="tx1"/>
                </a:solidFill>
              </a:defRPr>
            </a:lvl1pPr>
            <a:lvl2pPr marL="315057" indent="0">
              <a:buNone/>
              <a:defRPr sz="1378">
                <a:solidFill>
                  <a:schemeClr val="tx1">
                    <a:tint val="75000"/>
                  </a:schemeClr>
                </a:solidFill>
              </a:defRPr>
            </a:lvl2pPr>
            <a:lvl3pPr marL="630113" indent="0">
              <a:buNone/>
              <a:defRPr sz="1240">
                <a:solidFill>
                  <a:schemeClr val="tx1">
                    <a:tint val="75000"/>
                  </a:schemeClr>
                </a:solidFill>
              </a:defRPr>
            </a:lvl3pPr>
            <a:lvl4pPr marL="945170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4pPr>
            <a:lvl5pPr marL="126022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5pPr>
            <a:lvl6pPr marL="1575283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6pPr>
            <a:lvl7pPr marL="1890339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7pPr>
            <a:lvl8pPr marL="220539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8pPr>
            <a:lvl9pPr marL="2520452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0BBC7-D874-9342-BA92-7CBABE999B84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47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2184834"/>
            <a:ext cx="2677835" cy="52075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2184834"/>
            <a:ext cx="2677835" cy="52075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32204-AAAF-1C42-9058-FAC7D190360F}" type="datetime1">
              <a:rPr lang="de-DE" smtClean="0"/>
              <a:t>23.12.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174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436968"/>
            <a:ext cx="5434430" cy="158638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1" y="2011948"/>
            <a:ext cx="2665528" cy="986024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1" y="2997972"/>
            <a:ext cx="2665528" cy="440956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2011948"/>
            <a:ext cx="2678656" cy="986024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2997972"/>
            <a:ext cx="2678656" cy="440956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32EC-4446-4244-8EFE-AC02BF8296C6}" type="datetime1">
              <a:rPr lang="de-DE" smtClean="0"/>
              <a:t>23.12.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408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D91BE-5A90-C642-9C1B-B5E2A0553440}" type="datetime1">
              <a:rPr lang="de-DE" smtClean="0"/>
              <a:t>23.12.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756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11584-0253-0849-8994-5C77550FC46D}" type="datetime1">
              <a:rPr lang="de-DE" smtClean="0"/>
              <a:t>23.12.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295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547158"/>
            <a:ext cx="2032168" cy="1915054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1181712"/>
            <a:ext cx="3189774" cy="5832556"/>
          </a:xfrm>
        </p:spPr>
        <p:txBody>
          <a:bodyPr/>
          <a:lstStyle>
            <a:lvl1pPr>
              <a:defRPr sz="2205"/>
            </a:lvl1pPr>
            <a:lvl2pPr>
              <a:defRPr sz="1929"/>
            </a:lvl2pPr>
            <a:lvl3pPr>
              <a:defRPr sz="1654"/>
            </a:lvl3pPr>
            <a:lvl4pPr>
              <a:defRPr sz="1378"/>
            </a:lvl4pPr>
            <a:lvl5pPr>
              <a:defRPr sz="1378"/>
            </a:lvl5pPr>
            <a:lvl6pPr>
              <a:defRPr sz="1378"/>
            </a:lvl6pPr>
            <a:lvl7pPr>
              <a:defRPr sz="1378"/>
            </a:lvl7pPr>
            <a:lvl8pPr>
              <a:defRPr sz="1378"/>
            </a:lvl8pPr>
            <a:lvl9pPr>
              <a:defRPr sz="1378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462213"/>
            <a:ext cx="2032168" cy="4561553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4D6EF-E6DD-CA4B-9960-C5DE565EFD36}" type="datetime1">
              <a:rPr lang="de-DE" smtClean="0"/>
              <a:t>23.12.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76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547158"/>
            <a:ext cx="2032168" cy="1915054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1181712"/>
            <a:ext cx="3189774" cy="5832556"/>
          </a:xfrm>
        </p:spPr>
        <p:txBody>
          <a:bodyPr anchor="t"/>
          <a:lstStyle>
            <a:lvl1pPr marL="0" indent="0">
              <a:buNone/>
              <a:defRPr sz="2205"/>
            </a:lvl1pPr>
            <a:lvl2pPr marL="315057" indent="0">
              <a:buNone/>
              <a:defRPr sz="1929"/>
            </a:lvl2pPr>
            <a:lvl3pPr marL="630113" indent="0">
              <a:buNone/>
              <a:defRPr sz="1654"/>
            </a:lvl3pPr>
            <a:lvl4pPr marL="945170" indent="0">
              <a:buNone/>
              <a:defRPr sz="1378"/>
            </a:lvl4pPr>
            <a:lvl5pPr marL="1260226" indent="0">
              <a:buNone/>
              <a:defRPr sz="1378"/>
            </a:lvl5pPr>
            <a:lvl6pPr marL="1575283" indent="0">
              <a:buNone/>
              <a:defRPr sz="1378"/>
            </a:lvl6pPr>
            <a:lvl7pPr marL="1890339" indent="0">
              <a:buNone/>
              <a:defRPr sz="1378"/>
            </a:lvl7pPr>
            <a:lvl8pPr marL="2205396" indent="0">
              <a:buNone/>
              <a:defRPr sz="1378"/>
            </a:lvl8pPr>
            <a:lvl9pPr marL="2520452" indent="0">
              <a:buNone/>
              <a:defRPr sz="1378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462213"/>
            <a:ext cx="2032168" cy="4561553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89163-5445-AE42-B8FD-E7F7346026DA}" type="datetime1">
              <a:rPr lang="de-DE" smtClean="0"/>
              <a:t>23.12.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074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436968"/>
            <a:ext cx="5434430" cy="15863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2184834"/>
            <a:ext cx="5434430" cy="5207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7607022"/>
            <a:ext cx="1417677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DEBC2-67ED-884E-A821-17FB42EDB145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7607022"/>
            <a:ext cx="2126516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7607022"/>
            <a:ext cx="1417677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794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l" defTabSz="630113" rtl="0" eaLnBrk="1" latinLnBrk="0" hangingPunct="1">
        <a:lnSpc>
          <a:spcPct val="90000"/>
        </a:lnSpc>
        <a:spcBef>
          <a:spcPct val="0"/>
        </a:spcBef>
        <a:buNone/>
        <a:defRPr sz="303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28" indent="-157528" algn="l" defTabSz="63011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1pPr>
      <a:lvl2pPr marL="472585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78764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8" kern="1200">
          <a:solidFill>
            <a:schemeClr val="tx1"/>
          </a:solidFill>
          <a:latin typeface="+mn-lt"/>
          <a:ea typeface="+mn-ea"/>
          <a:cs typeface="+mn-cs"/>
        </a:defRPr>
      </a:lvl3pPr>
      <a:lvl4pPr marL="1102698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41775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73281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2047867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36292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677980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1pPr>
      <a:lvl2pPr marL="315057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2pPr>
      <a:lvl3pPr marL="63011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3pPr>
      <a:lvl4pPr marL="94517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26022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57528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1890339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20539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520452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1.tiff"/><Relationship Id="rId21" Type="http://schemas.openxmlformats.org/officeDocument/2006/relationships/image" Target="../media/image19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20" Type="http://schemas.openxmlformats.org/officeDocument/2006/relationships/image" Target="../media/image1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24" Type="http://schemas.openxmlformats.org/officeDocument/2006/relationships/image" Target="../media/image22.tiff"/><Relationship Id="rId5" Type="http://schemas.openxmlformats.org/officeDocument/2006/relationships/image" Target="../media/image3.tiff"/><Relationship Id="rId15" Type="http://schemas.openxmlformats.org/officeDocument/2006/relationships/image" Target="../media/image13.tiff"/><Relationship Id="rId23" Type="http://schemas.openxmlformats.org/officeDocument/2006/relationships/image" Target="../media/image21.tiff"/><Relationship Id="rId10" Type="http://schemas.openxmlformats.org/officeDocument/2006/relationships/image" Target="../media/image8.tiff"/><Relationship Id="rId19" Type="http://schemas.openxmlformats.org/officeDocument/2006/relationships/image" Target="../media/image17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tiff"/><Relationship Id="rId22" Type="http://schemas.openxmlformats.org/officeDocument/2006/relationships/image" Target="../media/image20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BFF308-7048-241B-8BE7-ECA48D2330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7486" y="50344"/>
            <a:ext cx="4900750" cy="381545"/>
          </a:xfrm>
        </p:spPr>
        <p:txBody>
          <a:bodyPr>
            <a:normAutofit fontScale="90000"/>
          </a:bodyPr>
          <a:lstStyle/>
          <a:p>
            <a:r>
              <a:rPr lang="en-US" sz="149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491" dirty="0" smtClean="0">
                <a:latin typeface="Arial" panose="020B0604020202020204" pitchFamily="34" charset="0"/>
                <a:cs typeface="Arial" panose="020B0604020202020204" pitchFamily="34" charset="0"/>
              </a:rPr>
              <a:t>Fig. 3. </a:t>
            </a:r>
            <a:r>
              <a:rPr lang="en-US" sz="1491" dirty="0">
                <a:latin typeface="Arial" panose="020B0604020202020204" pitchFamily="34" charset="0"/>
                <a:cs typeface="Arial" panose="020B0604020202020204" pitchFamily="34" charset="0"/>
              </a:rPr>
              <a:t>Neutrophil recruitment depends on STIM1 and ORAI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37D25F5-F5C7-3624-F445-FE1847F0B5A1}"/>
              </a:ext>
            </a:extLst>
          </p:cNvPr>
          <p:cNvSpPr txBox="1"/>
          <p:nvPr/>
        </p:nvSpPr>
        <p:spPr>
          <a:xfrm>
            <a:off x="412316" y="498766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48C49CC-900E-934A-302C-8ABD6FA4B70D}"/>
              </a:ext>
            </a:extLst>
          </p:cNvPr>
          <p:cNvSpPr txBox="1"/>
          <p:nvPr/>
        </p:nvSpPr>
        <p:spPr>
          <a:xfrm>
            <a:off x="1747675" y="498766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F581568-1212-07FD-5EBB-6A7F90173C60}"/>
              </a:ext>
            </a:extLst>
          </p:cNvPr>
          <p:cNvSpPr txBox="1"/>
          <p:nvPr/>
        </p:nvSpPr>
        <p:spPr>
          <a:xfrm>
            <a:off x="3154587" y="498766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F64E5F3-65B9-0FAF-C8A8-FB4EE8C602B7}"/>
              </a:ext>
            </a:extLst>
          </p:cNvPr>
          <p:cNvSpPr txBox="1"/>
          <p:nvPr/>
        </p:nvSpPr>
        <p:spPr>
          <a:xfrm>
            <a:off x="1783337" y="1600651"/>
            <a:ext cx="27603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5E3DB2C-B53B-59B8-CA65-057D6EB7E5E1}"/>
              </a:ext>
            </a:extLst>
          </p:cNvPr>
          <p:cNvSpPr txBox="1"/>
          <p:nvPr/>
        </p:nvSpPr>
        <p:spPr>
          <a:xfrm>
            <a:off x="412317" y="1600651"/>
            <a:ext cx="28405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81A8CF9-239B-59BE-0250-DC6B744B15E6}"/>
              </a:ext>
            </a:extLst>
          </p:cNvPr>
          <p:cNvSpPr txBox="1"/>
          <p:nvPr/>
        </p:nvSpPr>
        <p:spPr>
          <a:xfrm>
            <a:off x="4416825" y="498766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A3AF931-FF57-944B-6E00-A2A9B613684D}"/>
              </a:ext>
            </a:extLst>
          </p:cNvPr>
          <p:cNvSpPr txBox="1"/>
          <p:nvPr/>
        </p:nvSpPr>
        <p:spPr>
          <a:xfrm>
            <a:off x="3154587" y="1600651"/>
            <a:ext cx="30008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0FEF66B-6BF6-F945-CABF-14F2FACF1131}"/>
              </a:ext>
            </a:extLst>
          </p:cNvPr>
          <p:cNvSpPr txBox="1"/>
          <p:nvPr/>
        </p:nvSpPr>
        <p:spPr>
          <a:xfrm>
            <a:off x="4416825" y="1600651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63381AC-7E17-B964-3C1A-FA57419F0A74}"/>
              </a:ext>
            </a:extLst>
          </p:cNvPr>
          <p:cNvSpPr txBox="1"/>
          <p:nvPr/>
        </p:nvSpPr>
        <p:spPr>
          <a:xfrm>
            <a:off x="412316" y="2605115"/>
            <a:ext cx="226344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E46BB5F-7EF2-E42E-5346-424E347D3C75}"/>
              </a:ext>
            </a:extLst>
          </p:cNvPr>
          <p:cNvSpPr txBox="1"/>
          <p:nvPr/>
        </p:nvSpPr>
        <p:spPr>
          <a:xfrm>
            <a:off x="3154587" y="2605115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C8A5CEE-EACC-11BE-F14F-89C867016D31}"/>
              </a:ext>
            </a:extLst>
          </p:cNvPr>
          <p:cNvSpPr txBox="1"/>
          <p:nvPr/>
        </p:nvSpPr>
        <p:spPr>
          <a:xfrm>
            <a:off x="1826494" y="2605115"/>
            <a:ext cx="26802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88E81AD-B708-835E-FAF4-2EE6042CB5A2}"/>
              </a:ext>
            </a:extLst>
          </p:cNvPr>
          <p:cNvSpPr txBox="1"/>
          <p:nvPr/>
        </p:nvSpPr>
        <p:spPr>
          <a:xfrm>
            <a:off x="4416825" y="2605115"/>
            <a:ext cx="27603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FEFD6AB-D3F0-016C-CD46-787498B5DC85}"/>
              </a:ext>
            </a:extLst>
          </p:cNvPr>
          <p:cNvSpPr txBox="1"/>
          <p:nvPr/>
        </p:nvSpPr>
        <p:spPr>
          <a:xfrm>
            <a:off x="412317" y="3609579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DA0A711-D774-A8A0-DBE5-7543C061AFD6}"/>
              </a:ext>
            </a:extLst>
          </p:cNvPr>
          <p:cNvSpPr txBox="1"/>
          <p:nvPr/>
        </p:nvSpPr>
        <p:spPr>
          <a:xfrm>
            <a:off x="1774969" y="3609579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0719235-FE98-325F-523B-934AC5517086}"/>
              </a:ext>
            </a:extLst>
          </p:cNvPr>
          <p:cNvSpPr txBox="1"/>
          <p:nvPr/>
        </p:nvSpPr>
        <p:spPr>
          <a:xfrm>
            <a:off x="3235747" y="4628748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A38E1CF-2FC3-851E-EA47-68B906B0B891}"/>
              </a:ext>
            </a:extLst>
          </p:cNvPr>
          <p:cNvSpPr txBox="1"/>
          <p:nvPr/>
        </p:nvSpPr>
        <p:spPr>
          <a:xfrm>
            <a:off x="4416825" y="3609579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7FD164A-C212-EC44-23A6-D9B135DFAB3F}"/>
              </a:ext>
            </a:extLst>
          </p:cNvPr>
          <p:cNvSpPr txBox="1"/>
          <p:nvPr/>
        </p:nvSpPr>
        <p:spPr>
          <a:xfrm>
            <a:off x="412317" y="4628748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1D27014C-AD73-671C-354D-DB75D98497FB}"/>
              </a:ext>
            </a:extLst>
          </p:cNvPr>
          <p:cNvSpPr txBox="1"/>
          <p:nvPr/>
        </p:nvSpPr>
        <p:spPr>
          <a:xfrm>
            <a:off x="1805473" y="4628748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pic>
        <p:nvPicPr>
          <p:cNvPr id="11" name="Picture 10" descr="A pixelated image of a purple rectangular object with white dots&#10;&#10;AI-generated content may be incorrect.">
            <a:extLst>
              <a:ext uri="{FF2B5EF4-FFF2-40B4-BE49-F238E27FC236}">
                <a16:creationId xmlns:a16="http://schemas.microsoft.com/office/drawing/2014/main" id="{C094907D-A0C4-5815-C693-FC995556AC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5635" y="2740536"/>
            <a:ext cx="1143525" cy="837582"/>
          </a:xfrm>
          <a:prstGeom prst="rect">
            <a:avLst/>
          </a:prstGeom>
        </p:spPr>
      </p:pic>
      <p:pic>
        <p:nvPicPr>
          <p:cNvPr id="23" name="Picture 22" descr="A purple and white pixelated object&#10;&#10;AI-generated content may be incorrect.">
            <a:extLst>
              <a:ext uri="{FF2B5EF4-FFF2-40B4-BE49-F238E27FC236}">
                <a16:creationId xmlns:a16="http://schemas.microsoft.com/office/drawing/2014/main" id="{AFF0E6E8-CF20-7DBB-3D7D-87F2B630E3F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38956" y="601129"/>
            <a:ext cx="1103401" cy="897767"/>
          </a:xfrm>
          <a:prstGeom prst="rect">
            <a:avLst/>
          </a:prstGeom>
        </p:spPr>
      </p:pic>
      <p:pic>
        <p:nvPicPr>
          <p:cNvPr id="25" name="Picture 24" descr="A pixelated video game&#10;&#10;AI-generated content may be incorrect.">
            <a:extLst>
              <a:ext uri="{FF2B5EF4-FFF2-40B4-BE49-F238E27FC236}">
                <a16:creationId xmlns:a16="http://schemas.microsoft.com/office/drawing/2014/main" id="{2D5FE138-19DA-BFBC-57C2-5CC9711B18A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57565" y="2792059"/>
            <a:ext cx="1078324" cy="817520"/>
          </a:xfrm>
          <a:prstGeom prst="rect">
            <a:avLst/>
          </a:prstGeom>
        </p:spPr>
      </p:pic>
      <p:pic>
        <p:nvPicPr>
          <p:cNvPr id="31" name="Picture 30" descr="A pixelated video game&#10;&#10;AI-generated content may be incorrect.">
            <a:extLst>
              <a:ext uri="{FF2B5EF4-FFF2-40B4-BE49-F238E27FC236}">
                <a16:creationId xmlns:a16="http://schemas.microsoft.com/office/drawing/2014/main" id="{F68E2ADB-FFD2-0CBA-24C9-8E0A907514B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4906" y="4910069"/>
            <a:ext cx="1143525" cy="882721"/>
          </a:xfrm>
          <a:prstGeom prst="rect">
            <a:avLst/>
          </a:prstGeom>
        </p:spPr>
      </p:pic>
      <p:pic>
        <p:nvPicPr>
          <p:cNvPr id="33" name="Picture 32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09BC3D05-03D5-8F2E-FDB7-F9686A16D7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37383" y="1785342"/>
            <a:ext cx="1083339" cy="822535"/>
          </a:xfrm>
          <a:prstGeom prst="rect">
            <a:avLst/>
          </a:prstGeom>
        </p:spPr>
      </p:pic>
      <p:pic>
        <p:nvPicPr>
          <p:cNvPr id="38" name="Picture 37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70BD50F1-3BA7-AC12-2059-24CA49BE614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57565" y="4979924"/>
            <a:ext cx="1123463" cy="822535"/>
          </a:xfrm>
          <a:prstGeom prst="rect">
            <a:avLst/>
          </a:prstGeom>
        </p:spPr>
      </p:pic>
      <p:pic>
        <p:nvPicPr>
          <p:cNvPr id="40" name="Picture 39" descr="A pixelated video game&#10;&#10;AI-generated content may be incorrect.">
            <a:extLst>
              <a:ext uri="{FF2B5EF4-FFF2-40B4-BE49-F238E27FC236}">
                <a16:creationId xmlns:a16="http://schemas.microsoft.com/office/drawing/2014/main" id="{89F4BEDE-B9E7-C33E-0859-6367BABC088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43207" y="1885281"/>
            <a:ext cx="1173618" cy="817520"/>
          </a:xfrm>
          <a:prstGeom prst="rect">
            <a:avLst/>
          </a:prstGeom>
        </p:spPr>
      </p:pic>
      <p:pic>
        <p:nvPicPr>
          <p:cNvPr id="43" name="Picture 42" descr="A purple rectangular object with white dots&#10;&#10;AI-generated content may be incorrect.">
            <a:extLst>
              <a:ext uri="{FF2B5EF4-FFF2-40B4-BE49-F238E27FC236}">
                <a16:creationId xmlns:a16="http://schemas.microsoft.com/office/drawing/2014/main" id="{603F5B1C-436D-19C0-6C49-3D378114924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50107" y="710106"/>
            <a:ext cx="1078324" cy="852628"/>
          </a:xfrm>
          <a:prstGeom prst="rect">
            <a:avLst/>
          </a:prstGeom>
        </p:spPr>
      </p:pic>
      <p:pic>
        <p:nvPicPr>
          <p:cNvPr id="46" name="Picture 45" descr="A pixelated image of a purple door&#10;&#10;AI-generated content may be incorrect.">
            <a:extLst>
              <a:ext uri="{FF2B5EF4-FFF2-40B4-BE49-F238E27FC236}">
                <a16:creationId xmlns:a16="http://schemas.microsoft.com/office/drawing/2014/main" id="{17E7A568-AC86-89AA-D343-2853CB26FBE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44585" y="1877757"/>
            <a:ext cx="1118448" cy="832567"/>
          </a:xfrm>
          <a:prstGeom prst="rect">
            <a:avLst/>
          </a:prstGeom>
        </p:spPr>
      </p:pic>
      <p:pic>
        <p:nvPicPr>
          <p:cNvPr id="50" name="Picture 49" descr="A pixelated video game&#10;&#10;AI-generated content may be incorrect.">
            <a:extLst>
              <a:ext uri="{FF2B5EF4-FFF2-40B4-BE49-F238E27FC236}">
                <a16:creationId xmlns:a16="http://schemas.microsoft.com/office/drawing/2014/main" id="{81B1AF63-DB4F-FCFB-3061-8858B95156B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303637" y="2776032"/>
            <a:ext cx="1183649" cy="847613"/>
          </a:xfrm>
          <a:prstGeom prst="rect">
            <a:avLst/>
          </a:prstGeom>
        </p:spPr>
      </p:pic>
      <p:pic>
        <p:nvPicPr>
          <p:cNvPr id="52" name="Picture 51" descr="A blue and white letter&#10;&#10;AI-generated content may be incorrect.">
            <a:extLst>
              <a:ext uri="{FF2B5EF4-FFF2-40B4-BE49-F238E27FC236}">
                <a16:creationId xmlns:a16="http://schemas.microsoft.com/office/drawing/2014/main" id="{F6D04089-3349-C2D3-ABC6-9AC5070313D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298377" y="638663"/>
            <a:ext cx="1118448" cy="877706"/>
          </a:xfrm>
          <a:prstGeom prst="rect">
            <a:avLst/>
          </a:prstGeom>
        </p:spPr>
      </p:pic>
      <p:pic>
        <p:nvPicPr>
          <p:cNvPr id="62" name="Picture 61" descr="A video game screen with a black background&#10;&#10;AI-generated content may be incorrect.">
            <a:extLst>
              <a:ext uri="{FF2B5EF4-FFF2-40B4-BE49-F238E27FC236}">
                <a16:creationId xmlns:a16="http://schemas.microsoft.com/office/drawing/2014/main" id="{4440B975-4974-3FD3-03FB-BA039AC188E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565506" y="2800097"/>
            <a:ext cx="1128479" cy="817520"/>
          </a:xfrm>
          <a:prstGeom prst="rect">
            <a:avLst/>
          </a:prstGeom>
        </p:spPr>
      </p:pic>
      <p:pic>
        <p:nvPicPr>
          <p:cNvPr id="64" name="Picture 63" descr="A black background with white dots and pink rectangles&#10;&#10;AI-generated content may be incorrect.">
            <a:extLst>
              <a:ext uri="{FF2B5EF4-FFF2-40B4-BE49-F238E27FC236}">
                <a16:creationId xmlns:a16="http://schemas.microsoft.com/office/drawing/2014/main" id="{754256E8-D54D-0E08-1CC3-BBF50B9D9EA3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75635" y="3726474"/>
            <a:ext cx="1334113" cy="902783"/>
          </a:xfrm>
          <a:prstGeom prst="rect">
            <a:avLst/>
          </a:prstGeom>
        </p:spPr>
      </p:pic>
      <p:pic>
        <p:nvPicPr>
          <p:cNvPr id="66" name="Picture 65" descr="A pink rectangular object with white dots and a black background&#10;&#10;AI-generated content may be incorrect.">
            <a:extLst>
              <a:ext uri="{FF2B5EF4-FFF2-40B4-BE49-F238E27FC236}">
                <a16:creationId xmlns:a16="http://schemas.microsoft.com/office/drawing/2014/main" id="{96CF3160-309E-F1A7-6897-921DA87CFD2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544585" y="646645"/>
            <a:ext cx="1263896" cy="927860"/>
          </a:xfrm>
          <a:prstGeom prst="rect">
            <a:avLst/>
          </a:prstGeom>
        </p:spPr>
      </p:pic>
      <p:pic>
        <p:nvPicPr>
          <p:cNvPr id="68" name="Picture 67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DE962464-FE18-0437-201D-71733F7C389E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993152" y="3793761"/>
            <a:ext cx="1273927" cy="822536"/>
          </a:xfrm>
          <a:prstGeom prst="rect">
            <a:avLst/>
          </a:prstGeom>
        </p:spPr>
      </p:pic>
      <p:pic>
        <p:nvPicPr>
          <p:cNvPr id="70" name="Picture 69" descr="A screen shot of a game&#10;&#10;AI-generated content may be incorrect.">
            <a:extLst>
              <a:ext uri="{FF2B5EF4-FFF2-40B4-BE49-F238E27FC236}">
                <a16:creationId xmlns:a16="http://schemas.microsoft.com/office/drawing/2014/main" id="{5A36CF55-A7AD-EDA4-3CEF-E1D85F6A89C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273371" y="3810417"/>
            <a:ext cx="1173618" cy="832567"/>
          </a:xfrm>
          <a:prstGeom prst="rect">
            <a:avLst/>
          </a:prstGeom>
        </p:spPr>
      </p:pic>
      <p:pic>
        <p:nvPicPr>
          <p:cNvPr id="72" name="Picture 71" descr="A pixel art of a letter t&#10;&#10;AI-generated content may be incorrect.">
            <a:extLst>
              <a:ext uri="{FF2B5EF4-FFF2-40B4-BE49-F238E27FC236}">
                <a16:creationId xmlns:a16="http://schemas.microsoft.com/office/drawing/2014/main" id="{19E3E985-17A5-3445-2C61-11DCB5E2369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62646" y="1740649"/>
            <a:ext cx="1053247" cy="897768"/>
          </a:xfrm>
          <a:prstGeom prst="rect">
            <a:avLst/>
          </a:prstGeom>
        </p:spPr>
      </p:pic>
      <p:pic>
        <p:nvPicPr>
          <p:cNvPr id="74" name="Picture 73" descr="A video game screen with a black background&#10;&#10;AI-generated content may be incorrect.">
            <a:extLst>
              <a:ext uri="{FF2B5EF4-FFF2-40B4-BE49-F238E27FC236}">
                <a16:creationId xmlns:a16="http://schemas.microsoft.com/office/drawing/2014/main" id="{CC3CEA0F-B86C-AF80-50C4-086F12FFD80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539569" y="3810417"/>
            <a:ext cx="1128479" cy="85262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F3BAAE9-A7AE-1B74-6203-BF02783296DC}"/>
              </a:ext>
            </a:extLst>
          </p:cNvPr>
          <p:cNvSpPr txBox="1"/>
          <p:nvPr/>
        </p:nvSpPr>
        <p:spPr>
          <a:xfrm>
            <a:off x="4531579" y="4628748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390C35E-AA03-1955-B405-84E882B3B1A0}"/>
              </a:ext>
            </a:extLst>
          </p:cNvPr>
          <p:cNvSpPr txBox="1"/>
          <p:nvPr/>
        </p:nvSpPr>
        <p:spPr>
          <a:xfrm>
            <a:off x="416497" y="6170543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</a:p>
        </p:txBody>
      </p:sp>
      <p:pic>
        <p:nvPicPr>
          <p:cNvPr id="9" name="Picture 8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6DEB39DB-A021-3CE2-B9A7-5DCE925A1587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1937383" y="5859184"/>
            <a:ext cx="1390719" cy="1549094"/>
          </a:xfrm>
          <a:prstGeom prst="rect">
            <a:avLst/>
          </a:prstGeom>
        </p:spPr>
      </p:pic>
      <p:pic>
        <p:nvPicPr>
          <p:cNvPr id="12" name="Picture 11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9FAE2D20-4629-D047-607D-405422F025B8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3480409" y="4641200"/>
            <a:ext cx="974569" cy="1161259"/>
          </a:xfrm>
          <a:prstGeom prst="rect">
            <a:avLst/>
          </a:prstGeom>
        </p:spPr>
      </p:pic>
      <p:pic>
        <p:nvPicPr>
          <p:cNvPr id="14" name="Picture 13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E14F1C64-CFC4-4517-8A8B-8EAF7C5E390B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4649915" y="4910069"/>
            <a:ext cx="1262041" cy="895801"/>
          </a:xfrm>
          <a:prstGeom prst="rect">
            <a:avLst/>
          </a:prstGeom>
        </p:spPr>
      </p:pic>
      <p:pic>
        <p:nvPicPr>
          <p:cNvPr id="27" name="Picture 26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39DF9639-28BB-3A40-BF3E-F33844036F5B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63290" y="6338064"/>
            <a:ext cx="1148210" cy="930445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68414000-9B51-14DE-4CF8-DBF29B1F4614}"/>
              </a:ext>
            </a:extLst>
          </p:cNvPr>
          <p:cNvSpPr txBox="1"/>
          <p:nvPr/>
        </p:nvSpPr>
        <p:spPr>
          <a:xfrm>
            <a:off x="1833474" y="6139380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sp>
        <p:nvSpPr>
          <p:cNvPr id="47" name="TextBox 33">
            <a:extLst>
              <a:ext uri="{FF2B5EF4-FFF2-40B4-BE49-F238E27FC236}">
                <a16:creationId xmlns:a16="http://schemas.microsoft.com/office/drawing/2014/main" id="{6A38E1CF-2FC3-851E-EA47-68B906B0B891}"/>
              </a:ext>
            </a:extLst>
          </p:cNvPr>
          <p:cNvSpPr txBox="1"/>
          <p:nvPr/>
        </p:nvSpPr>
        <p:spPr>
          <a:xfrm>
            <a:off x="3161388" y="3609579"/>
            <a:ext cx="236673" cy="2708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60" b="1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endParaRPr lang="en-US" sz="116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33709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2FAB84-5B01-6889-AE2E-C5561F8E491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A9EED49D-4E16-61C3-5F23-D635274635C0}"/>
              </a:ext>
            </a:extLst>
          </p:cNvPr>
          <p:cNvSpPr txBox="1"/>
          <p:nvPr/>
        </p:nvSpPr>
        <p:spPr>
          <a:xfrm>
            <a:off x="646046" y="414098"/>
            <a:ext cx="4755064" cy="496898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000" b="1" dirty="0">
                <a:latin typeface="Arial" panose="020B0604020202020204" pitchFamily="34" charset="0"/>
                <a:ea typeface="Calibri" panose="020F0502020204030204" pitchFamily="34" charset="0"/>
              </a:rPr>
              <a:t>Supplemental Fig. 3. Neutrophil recruitment depends on STIM1 and ORAI1.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</a:rPr>
              <a:t>Control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STIM1-KO = STIM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RAI1-KO = ORAI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STIM1/2-KO = STIM1/2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STIM1/ORAI1-KO = STIM1/ORAI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,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STIM2-KO = STIM2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 ,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RAI2-KO = ORAI2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Control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ORAI1-KO = ORAI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mice were injected intrascrotally with TNF-𝛼 (2 h) and analyzed for leukocyte recruitment. Representative postcapillary cremaster muscle venules were analyzed for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neutrophil rolling velocity and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the number of adherent neutrophils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U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</a:rPr>
              <a:t>Leukocyte transmigration was visualized using reflected light oblique transillumination microscopy (RLOT) and examined for the number of emigrated cells, n=3, number of mice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In control,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ysM</a:t>
            </a:r>
            <a:r>
              <a:rPr lang="en-US" sz="10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nd ORAI1-KO = ORAI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cre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neutrophils, either unstimulated or stimulated with CXCL-1, binding of fluorescently coupled β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integri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igan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CAM-1 was assessed by flow cytometry, n=3, experimental repeat.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</a:rPr>
              <a:t>Data are mean ± SEM. *p&lt;0.05, **p&lt;0.01, ***p&lt;0.0001, ns=non significant by one-way ANOVA.</a:t>
            </a:r>
          </a:p>
        </p:txBody>
      </p:sp>
    </p:spTree>
    <p:extLst>
      <p:ext uri="{BB962C8B-B14F-4D97-AF65-F5344CB8AC3E}">
        <p14:creationId xmlns:p14="http://schemas.microsoft.com/office/powerpoint/2010/main" val="15723981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293</Words>
  <Application>Microsoft Office PowerPoint</Application>
  <PresentationFormat>Benutzerdefiniert</PresentationFormat>
  <Paragraphs>26</Paragraphs>
  <Slides>2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2013 - 2022 Theme</vt:lpstr>
      <vt:lpstr>Supplemental Fig. 3. Neutrophil recruitment depends on STIM1 and ORAI1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lcium figure file</dc:title>
  <dc:creator>Marina Kardell</dc:creator>
  <cp:lastModifiedBy>Cappenberg</cp:lastModifiedBy>
  <cp:revision>198</cp:revision>
  <dcterms:created xsi:type="dcterms:W3CDTF">2023-11-02T11:54:21Z</dcterms:created>
  <dcterms:modified xsi:type="dcterms:W3CDTF">2025-12-23T07:38:19Z</dcterms:modified>
</cp:coreProperties>
</file>